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4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52" d="100"/>
          <a:sy n="152" d="100"/>
        </p:scale>
        <p:origin x="1988" y="108"/>
      </p:cViewPr>
      <p:guideLst>
        <p:guide orient="horz" pos="134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4442042"/>
            <a:ext cx="7992888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cLean et al (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2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solidFill>
                  <a:prstClr val="black"/>
                </a:solidFill>
                <a:latin typeface="Calibri"/>
              </a:rPr>
              <a:t>Reproduced from data from the National Pregnancy in Diabetes (NPID) Audit Report 2020 and the </a:t>
            </a:r>
            <a:r>
              <a:rPr lang="en-US" sz="1200" dirty="0">
                <a:solidFill>
                  <a:prstClr val="black"/>
                </a:solidFill>
                <a:latin typeface="Calibri"/>
              </a:rPr>
              <a:t>National Pregnancy in Diabetes (NPID) Audit Report 2021 and 202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ttps://digital.nhs.uk/data-and-information/publications/statistical/national-pregnancy-in-diabetes-audit/2019-and-202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ttps://digitalnhsuk/data-and-information/publications/statistical/national-pregnancy-in-diabetes-audit/202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(a) Serious adverse pregnancy outcomes according to early pregnancy HbA</a:t>
            </a:r>
            <a:r>
              <a:rPr lang="en-US" sz="1800" b="1" baseline="-25000" dirty="0"/>
              <a:t>1c</a:t>
            </a:r>
            <a:r>
              <a:rPr lang="en-US" sz="1800" b="1" dirty="0"/>
              <a:t> categories and (b) widening gaps in pregnancy preparation in type 1 and type 2 diabetes pregnancies 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07D1A2C-ACDD-577B-B6BB-F488996B5CF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48950"/>
          <a:stretch/>
        </p:blipFill>
        <p:spPr>
          <a:xfrm>
            <a:off x="532436" y="1992421"/>
            <a:ext cx="4114662" cy="237268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C91CD87-E05B-42F5-BD07-ECF37113FBE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1050"/>
          <a:stretch/>
        </p:blipFill>
        <p:spPr>
          <a:xfrm>
            <a:off x="4932040" y="1988840"/>
            <a:ext cx="3906961" cy="2160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(a) Preterm birth rates in type 1 and type 2 diabetes pregnancies and (b) LGA rates in type 1 and type 2 diabetes pregnancies according to maternal HbA</a:t>
            </a:r>
            <a:r>
              <a:rPr lang="en-US" b="1" baseline="-25000" dirty="0"/>
              <a:t>1c</a:t>
            </a:r>
            <a:r>
              <a:rPr lang="en-US" b="1" dirty="0"/>
              <a:t> categories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E12CBD9-F0A0-953C-CF4D-F0DEC00CA4D0}"/>
              </a:ext>
            </a:extLst>
          </p:cNvPr>
          <p:cNvSpPr txBox="1"/>
          <p:nvPr/>
        </p:nvSpPr>
        <p:spPr>
          <a:xfrm>
            <a:off x="251520" y="4653136"/>
            <a:ext cx="7992888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cLean et al (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21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solidFill>
                  <a:prstClr val="black"/>
                </a:solidFill>
                <a:latin typeface="Calibri"/>
              </a:rPr>
              <a:t>Reproduced from data from the National Pregnancy in Diabetes (NPID) Audit Report 202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ttps://digital.nhs.uk/data-and-information/publications/statistical/national-pregnancy-in-diabetes-audit/2019-and-202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AB75CAA-8055-EFA4-5896-4CB7FA6A8A7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51359"/>
          <a:stretch/>
        </p:blipFill>
        <p:spPr>
          <a:xfrm>
            <a:off x="577844" y="2063243"/>
            <a:ext cx="3888432" cy="219095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E7C7DD9-5907-4DB5-FD31-647DE2F005B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9039"/>
          <a:stretch/>
        </p:blipFill>
        <p:spPr>
          <a:xfrm>
            <a:off x="4716016" y="2060848"/>
            <a:ext cx="3888432" cy="229539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erious adverse pregnancy outcomes according to CGM use during type 1 diabetes pregnancies in 2021–2022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173D876-5147-744B-209C-FA6EBE191030}"/>
              </a:ext>
            </a:extLst>
          </p:cNvPr>
          <p:cNvSpPr txBox="1"/>
          <p:nvPr/>
        </p:nvSpPr>
        <p:spPr>
          <a:xfrm>
            <a:off x="323528" y="4827824"/>
            <a:ext cx="7992888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cLean et al (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21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solidFill>
                  <a:prstClr val="black"/>
                </a:solidFill>
                <a:latin typeface="Calibri"/>
              </a:rPr>
              <a:t>Reproduced from data from the National Pregnancy in Diabetes (NPID) Audit Report </a:t>
            </a:r>
            <a:r>
              <a:rPr lang="en-US" sz="1200" dirty="0">
                <a:solidFill>
                  <a:prstClr val="black"/>
                </a:solidFill>
                <a:latin typeface="Calibri"/>
              </a:rPr>
              <a:t>2021 and 202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ttps://digitalnhsuk/data-and-information/publications/statistical/national-pregnancy-in-diabetes-audit/202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352816C-43F0-F8DF-2271-A77F9FAE54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7704" y="1412776"/>
            <a:ext cx="5319337" cy="36936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0</Words>
  <Application>Microsoft Office PowerPoint</Application>
  <PresentationFormat>On-screen Show (4:3)</PresentationFormat>
  <Paragraphs>2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6</cp:revision>
  <dcterms:created xsi:type="dcterms:W3CDTF">2016-06-15T12:53:43Z</dcterms:created>
  <dcterms:modified xsi:type="dcterms:W3CDTF">2024-06-28T08:09:26Z</dcterms:modified>
</cp:coreProperties>
</file>